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744450" cy="11539538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905" userDrawn="1">
          <p15:clr>
            <a:srgbClr val="A4A3A4"/>
          </p15:clr>
        </p15:guide>
        <p15:guide id="2" pos="74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148" d="100"/>
          <a:sy n="148" d="100"/>
        </p:scale>
        <p:origin x="-2394" y="-5796"/>
      </p:cViewPr>
      <p:guideLst>
        <p:guide orient="horz" pos="4905"/>
        <p:guide pos="74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57C4087-F756-43C3-B42D-FF66B4F49274}" type="datetimeFigureOut">
              <a:rPr lang="en-US" smtClean="0"/>
              <a:t>3/24/2021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725613" y="1143000"/>
            <a:ext cx="340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E3E7FF8-E9F8-48BA-9BD1-349ADF3BF99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87819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E3E7FF8-E9F8-48BA-9BD1-349ADF3BF99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269573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955840" y="3584745"/>
            <a:ext cx="10832783" cy="2473521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911674" y="6539071"/>
            <a:ext cx="8921115" cy="294899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0246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80492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20739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60985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01232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41478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81724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21971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D73906-7207-4BB4-8463-9DDA4E4C50A2}" type="datetimeFigureOut">
              <a:rPr lang="en-US" smtClean="0"/>
              <a:t>3/24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3CE76-F9F0-4EE8-B10F-E6024933E0A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95062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D73906-7207-4BB4-8463-9DDA4E4C50A2}" type="datetimeFigureOut">
              <a:rPr lang="en-US" smtClean="0"/>
              <a:t>3/24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3CE76-F9F0-4EE8-B10F-E6024933E0A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68507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9239731" y="462124"/>
            <a:ext cx="2867501" cy="984600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637223" y="462124"/>
            <a:ext cx="8390096" cy="984600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D73906-7207-4BB4-8463-9DDA4E4C50A2}" type="datetimeFigureOut">
              <a:rPr lang="en-US" smtClean="0"/>
              <a:t>3/24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3CE76-F9F0-4EE8-B10F-E6024933E0A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50048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D73906-7207-4BB4-8463-9DDA4E4C50A2}" type="datetimeFigureOut">
              <a:rPr lang="en-US" smtClean="0"/>
              <a:t>3/24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3CE76-F9F0-4EE8-B10F-E6024933E0A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99256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006728" y="7415228"/>
            <a:ext cx="10832783" cy="2291880"/>
          </a:xfrm>
        </p:spPr>
        <p:txBody>
          <a:bodyPr anchor="t"/>
          <a:lstStyle>
            <a:lvl1pPr algn="l">
              <a:defRPr sz="3521" b="1" cap="all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1006728" y="4890953"/>
            <a:ext cx="10832783" cy="2524273"/>
          </a:xfrm>
        </p:spPr>
        <p:txBody>
          <a:bodyPr anchor="b"/>
          <a:lstStyle>
            <a:lvl1pPr marL="0" indent="0">
              <a:buNone/>
              <a:defRPr sz="1761">
                <a:solidFill>
                  <a:schemeClr val="tx1">
                    <a:tint val="75000"/>
                  </a:schemeClr>
                </a:solidFill>
              </a:defRPr>
            </a:lvl1pPr>
            <a:lvl2pPr marL="402463" indent="0">
              <a:buNone/>
              <a:defRPr sz="1585">
                <a:solidFill>
                  <a:schemeClr val="tx1">
                    <a:tint val="75000"/>
                  </a:schemeClr>
                </a:solidFill>
              </a:defRPr>
            </a:lvl2pPr>
            <a:lvl3pPr marL="804928" indent="0">
              <a:buNone/>
              <a:defRPr sz="1408">
                <a:solidFill>
                  <a:schemeClr val="tx1">
                    <a:tint val="75000"/>
                  </a:schemeClr>
                </a:solidFill>
              </a:defRPr>
            </a:lvl3pPr>
            <a:lvl4pPr marL="1207392" indent="0">
              <a:buNone/>
              <a:defRPr sz="1232">
                <a:solidFill>
                  <a:schemeClr val="tx1">
                    <a:tint val="75000"/>
                  </a:schemeClr>
                </a:solidFill>
              </a:defRPr>
            </a:lvl4pPr>
            <a:lvl5pPr marL="1609857" indent="0">
              <a:buNone/>
              <a:defRPr sz="1232">
                <a:solidFill>
                  <a:schemeClr val="tx1">
                    <a:tint val="75000"/>
                  </a:schemeClr>
                </a:solidFill>
              </a:defRPr>
            </a:lvl5pPr>
            <a:lvl6pPr marL="2012321" indent="0">
              <a:buNone/>
              <a:defRPr sz="1232">
                <a:solidFill>
                  <a:schemeClr val="tx1">
                    <a:tint val="75000"/>
                  </a:schemeClr>
                </a:solidFill>
              </a:defRPr>
            </a:lvl6pPr>
            <a:lvl7pPr marL="2414784" indent="0">
              <a:buNone/>
              <a:defRPr sz="1232">
                <a:solidFill>
                  <a:schemeClr val="tx1">
                    <a:tint val="75000"/>
                  </a:schemeClr>
                </a:solidFill>
              </a:defRPr>
            </a:lvl7pPr>
            <a:lvl8pPr marL="2817249" indent="0">
              <a:buNone/>
              <a:defRPr sz="1232">
                <a:solidFill>
                  <a:schemeClr val="tx1">
                    <a:tint val="75000"/>
                  </a:schemeClr>
                </a:solidFill>
              </a:defRPr>
            </a:lvl8pPr>
            <a:lvl9pPr marL="3219712" indent="0">
              <a:buNone/>
              <a:defRPr sz="123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D73906-7207-4BB4-8463-9DDA4E4C50A2}" type="datetimeFigureOut">
              <a:rPr lang="en-US" smtClean="0"/>
              <a:t>3/24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3CE76-F9F0-4EE8-B10F-E6024933E0A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70326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637227" y="2692567"/>
            <a:ext cx="5628799" cy="7615562"/>
          </a:xfrm>
        </p:spPr>
        <p:txBody>
          <a:bodyPr/>
          <a:lstStyle>
            <a:lvl1pPr>
              <a:defRPr sz="2465"/>
            </a:lvl1pPr>
            <a:lvl2pPr>
              <a:defRPr sz="2113"/>
            </a:lvl2pPr>
            <a:lvl3pPr>
              <a:defRPr sz="1761"/>
            </a:lvl3pPr>
            <a:lvl4pPr>
              <a:defRPr sz="1585"/>
            </a:lvl4pPr>
            <a:lvl5pPr>
              <a:defRPr sz="1585"/>
            </a:lvl5pPr>
            <a:lvl6pPr>
              <a:defRPr sz="1585"/>
            </a:lvl6pPr>
            <a:lvl7pPr>
              <a:defRPr sz="1585"/>
            </a:lvl7pPr>
            <a:lvl8pPr>
              <a:defRPr sz="1585"/>
            </a:lvl8pPr>
            <a:lvl9pPr>
              <a:defRPr sz="1585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478435" y="2692567"/>
            <a:ext cx="5628799" cy="7615562"/>
          </a:xfrm>
        </p:spPr>
        <p:txBody>
          <a:bodyPr/>
          <a:lstStyle>
            <a:lvl1pPr>
              <a:defRPr sz="2465"/>
            </a:lvl1pPr>
            <a:lvl2pPr>
              <a:defRPr sz="2113"/>
            </a:lvl2pPr>
            <a:lvl3pPr>
              <a:defRPr sz="1761"/>
            </a:lvl3pPr>
            <a:lvl4pPr>
              <a:defRPr sz="1585"/>
            </a:lvl4pPr>
            <a:lvl5pPr>
              <a:defRPr sz="1585"/>
            </a:lvl5pPr>
            <a:lvl6pPr>
              <a:defRPr sz="1585"/>
            </a:lvl6pPr>
            <a:lvl7pPr>
              <a:defRPr sz="1585"/>
            </a:lvl7pPr>
            <a:lvl8pPr>
              <a:defRPr sz="1585"/>
            </a:lvl8pPr>
            <a:lvl9pPr>
              <a:defRPr sz="1585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D73906-7207-4BB4-8463-9DDA4E4C50A2}" type="datetimeFigureOut">
              <a:rPr lang="en-US" smtClean="0"/>
              <a:t>3/24/2021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3CE76-F9F0-4EE8-B10F-E6024933E0A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55197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637223" y="2583043"/>
            <a:ext cx="5631012" cy="1076489"/>
          </a:xfrm>
        </p:spPr>
        <p:txBody>
          <a:bodyPr anchor="b"/>
          <a:lstStyle>
            <a:lvl1pPr marL="0" indent="0">
              <a:buNone/>
              <a:defRPr sz="2113" b="1"/>
            </a:lvl1pPr>
            <a:lvl2pPr marL="402463" indent="0">
              <a:buNone/>
              <a:defRPr sz="1761" b="1"/>
            </a:lvl2pPr>
            <a:lvl3pPr marL="804928" indent="0">
              <a:buNone/>
              <a:defRPr sz="1585" b="1"/>
            </a:lvl3pPr>
            <a:lvl4pPr marL="1207392" indent="0">
              <a:buNone/>
              <a:defRPr sz="1408" b="1"/>
            </a:lvl4pPr>
            <a:lvl5pPr marL="1609857" indent="0">
              <a:buNone/>
              <a:defRPr sz="1408" b="1"/>
            </a:lvl5pPr>
            <a:lvl6pPr marL="2012321" indent="0">
              <a:buNone/>
              <a:defRPr sz="1408" b="1"/>
            </a:lvl6pPr>
            <a:lvl7pPr marL="2414784" indent="0">
              <a:buNone/>
              <a:defRPr sz="1408" b="1"/>
            </a:lvl7pPr>
            <a:lvl8pPr marL="2817249" indent="0">
              <a:buNone/>
              <a:defRPr sz="1408" b="1"/>
            </a:lvl8pPr>
            <a:lvl9pPr marL="3219712" indent="0">
              <a:buNone/>
              <a:defRPr sz="1408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37223" y="3659530"/>
            <a:ext cx="5631012" cy="6648591"/>
          </a:xfrm>
        </p:spPr>
        <p:txBody>
          <a:bodyPr/>
          <a:lstStyle>
            <a:lvl1pPr>
              <a:defRPr sz="2113"/>
            </a:lvl1pPr>
            <a:lvl2pPr>
              <a:defRPr sz="1761"/>
            </a:lvl2pPr>
            <a:lvl3pPr>
              <a:defRPr sz="1585"/>
            </a:lvl3pPr>
            <a:lvl4pPr>
              <a:defRPr sz="1408"/>
            </a:lvl4pPr>
            <a:lvl5pPr>
              <a:defRPr sz="1408"/>
            </a:lvl5pPr>
            <a:lvl6pPr>
              <a:defRPr sz="1408"/>
            </a:lvl6pPr>
            <a:lvl7pPr>
              <a:defRPr sz="1408"/>
            </a:lvl7pPr>
            <a:lvl8pPr>
              <a:defRPr sz="1408"/>
            </a:lvl8pPr>
            <a:lvl9pPr>
              <a:defRPr sz="1408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474004" y="2583043"/>
            <a:ext cx="5633224" cy="1076489"/>
          </a:xfrm>
        </p:spPr>
        <p:txBody>
          <a:bodyPr anchor="b"/>
          <a:lstStyle>
            <a:lvl1pPr marL="0" indent="0">
              <a:buNone/>
              <a:defRPr sz="2113" b="1"/>
            </a:lvl1pPr>
            <a:lvl2pPr marL="402463" indent="0">
              <a:buNone/>
              <a:defRPr sz="1761" b="1"/>
            </a:lvl2pPr>
            <a:lvl3pPr marL="804928" indent="0">
              <a:buNone/>
              <a:defRPr sz="1585" b="1"/>
            </a:lvl3pPr>
            <a:lvl4pPr marL="1207392" indent="0">
              <a:buNone/>
              <a:defRPr sz="1408" b="1"/>
            </a:lvl4pPr>
            <a:lvl5pPr marL="1609857" indent="0">
              <a:buNone/>
              <a:defRPr sz="1408" b="1"/>
            </a:lvl5pPr>
            <a:lvl6pPr marL="2012321" indent="0">
              <a:buNone/>
              <a:defRPr sz="1408" b="1"/>
            </a:lvl6pPr>
            <a:lvl7pPr marL="2414784" indent="0">
              <a:buNone/>
              <a:defRPr sz="1408" b="1"/>
            </a:lvl7pPr>
            <a:lvl8pPr marL="2817249" indent="0">
              <a:buNone/>
              <a:defRPr sz="1408" b="1"/>
            </a:lvl8pPr>
            <a:lvl9pPr marL="3219712" indent="0">
              <a:buNone/>
              <a:defRPr sz="1408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474004" y="3659530"/>
            <a:ext cx="5633224" cy="6648591"/>
          </a:xfrm>
        </p:spPr>
        <p:txBody>
          <a:bodyPr/>
          <a:lstStyle>
            <a:lvl1pPr>
              <a:defRPr sz="2113"/>
            </a:lvl1pPr>
            <a:lvl2pPr>
              <a:defRPr sz="1761"/>
            </a:lvl2pPr>
            <a:lvl3pPr>
              <a:defRPr sz="1585"/>
            </a:lvl3pPr>
            <a:lvl4pPr>
              <a:defRPr sz="1408"/>
            </a:lvl4pPr>
            <a:lvl5pPr>
              <a:defRPr sz="1408"/>
            </a:lvl5pPr>
            <a:lvl6pPr>
              <a:defRPr sz="1408"/>
            </a:lvl6pPr>
            <a:lvl7pPr>
              <a:defRPr sz="1408"/>
            </a:lvl7pPr>
            <a:lvl8pPr>
              <a:defRPr sz="1408"/>
            </a:lvl8pPr>
            <a:lvl9pPr>
              <a:defRPr sz="1408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D73906-7207-4BB4-8463-9DDA4E4C50A2}" type="datetimeFigureOut">
              <a:rPr lang="en-US" smtClean="0"/>
              <a:t>3/24/2021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3CE76-F9F0-4EE8-B10F-E6024933E0A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30214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D73906-7207-4BB4-8463-9DDA4E4C50A2}" type="datetimeFigureOut">
              <a:rPr lang="en-US" smtClean="0"/>
              <a:t>3/24/2021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3CE76-F9F0-4EE8-B10F-E6024933E0A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55549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D73906-7207-4BB4-8463-9DDA4E4C50A2}" type="datetimeFigureOut">
              <a:rPr lang="en-US" smtClean="0"/>
              <a:t>3/24/2021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3CE76-F9F0-4EE8-B10F-E6024933E0A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90574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637223" y="459445"/>
            <a:ext cx="4192836" cy="1955312"/>
          </a:xfrm>
        </p:spPr>
        <p:txBody>
          <a:bodyPr anchor="b"/>
          <a:lstStyle>
            <a:lvl1pPr algn="l">
              <a:defRPr sz="1761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4982726" y="459453"/>
            <a:ext cx="7124502" cy="9848676"/>
          </a:xfrm>
        </p:spPr>
        <p:txBody>
          <a:bodyPr/>
          <a:lstStyle>
            <a:lvl1pPr>
              <a:defRPr sz="2817"/>
            </a:lvl1pPr>
            <a:lvl2pPr>
              <a:defRPr sz="2465"/>
            </a:lvl2pPr>
            <a:lvl3pPr>
              <a:defRPr sz="2113"/>
            </a:lvl3pPr>
            <a:lvl4pPr>
              <a:defRPr sz="1761"/>
            </a:lvl4pPr>
            <a:lvl5pPr>
              <a:defRPr sz="1761"/>
            </a:lvl5pPr>
            <a:lvl6pPr>
              <a:defRPr sz="1761"/>
            </a:lvl6pPr>
            <a:lvl7pPr>
              <a:defRPr sz="1761"/>
            </a:lvl7pPr>
            <a:lvl8pPr>
              <a:defRPr sz="1761"/>
            </a:lvl8pPr>
            <a:lvl9pPr>
              <a:defRPr sz="1761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637223" y="2414764"/>
            <a:ext cx="4192836" cy="7893365"/>
          </a:xfrm>
        </p:spPr>
        <p:txBody>
          <a:bodyPr/>
          <a:lstStyle>
            <a:lvl1pPr marL="0" indent="0">
              <a:buNone/>
              <a:defRPr sz="1232"/>
            </a:lvl1pPr>
            <a:lvl2pPr marL="402463" indent="0">
              <a:buNone/>
              <a:defRPr sz="1056"/>
            </a:lvl2pPr>
            <a:lvl3pPr marL="804928" indent="0">
              <a:buNone/>
              <a:defRPr sz="880"/>
            </a:lvl3pPr>
            <a:lvl4pPr marL="1207392" indent="0">
              <a:buNone/>
              <a:defRPr sz="792"/>
            </a:lvl4pPr>
            <a:lvl5pPr marL="1609857" indent="0">
              <a:buNone/>
              <a:defRPr sz="792"/>
            </a:lvl5pPr>
            <a:lvl6pPr marL="2012321" indent="0">
              <a:buNone/>
              <a:defRPr sz="792"/>
            </a:lvl6pPr>
            <a:lvl7pPr marL="2414784" indent="0">
              <a:buNone/>
              <a:defRPr sz="792"/>
            </a:lvl7pPr>
            <a:lvl8pPr marL="2817249" indent="0">
              <a:buNone/>
              <a:defRPr sz="792"/>
            </a:lvl8pPr>
            <a:lvl9pPr marL="3219712" indent="0">
              <a:buNone/>
              <a:defRPr sz="792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D73906-7207-4BB4-8463-9DDA4E4C50A2}" type="datetimeFigureOut">
              <a:rPr lang="en-US" smtClean="0"/>
              <a:t>3/24/2021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3CE76-F9F0-4EE8-B10F-E6024933E0A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50329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2498001" y="8077677"/>
            <a:ext cx="7646670" cy="953615"/>
          </a:xfrm>
        </p:spPr>
        <p:txBody>
          <a:bodyPr anchor="b"/>
          <a:lstStyle>
            <a:lvl1pPr algn="l">
              <a:defRPr sz="1761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2498001" y="1031080"/>
            <a:ext cx="7646670" cy="6923723"/>
          </a:xfrm>
        </p:spPr>
        <p:txBody>
          <a:bodyPr/>
          <a:lstStyle>
            <a:lvl1pPr marL="0" indent="0">
              <a:buNone/>
              <a:defRPr sz="2817"/>
            </a:lvl1pPr>
            <a:lvl2pPr marL="402463" indent="0">
              <a:buNone/>
              <a:defRPr sz="2465"/>
            </a:lvl2pPr>
            <a:lvl3pPr marL="804928" indent="0">
              <a:buNone/>
              <a:defRPr sz="2113"/>
            </a:lvl3pPr>
            <a:lvl4pPr marL="1207392" indent="0">
              <a:buNone/>
              <a:defRPr sz="1761"/>
            </a:lvl4pPr>
            <a:lvl5pPr marL="1609857" indent="0">
              <a:buNone/>
              <a:defRPr sz="1761"/>
            </a:lvl5pPr>
            <a:lvl6pPr marL="2012321" indent="0">
              <a:buNone/>
              <a:defRPr sz="1761"/>
            </a:lvl6pPr>
            <a:lvl7pPr marL="2414784" indent="0">
              <a:buNone/>
              <a:defRPr sz="1761"/>
            </a:lvl7pPr>
            <a:lvl8pPr marL="2817249" indent="0">
              <a:buNone/>
              <a:defRPr sz="1761"/>
            </a:lvl8pPr>
            <a:lvl9pPr marL="3219712" indent="0">
              <a:buNone/>
              <a:defRPr sz="1761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2498001" y="9031292"/>
            <a:ext cx="7646670" cy="1354293"/>
          </a:xfrm>
        </p:spPr>
        <p:txBody>
          <a:bodyPr/>
          <a:lstStyle>
            <a:lvl1pPr marL="0" indent="0">
              <a:buNone/>
              <a:defRPr sz="1232"/>
            </a:lvl1pPr>
            <a:lvl2pPr marL="402463" indent="0">
              <a:buNone/>
              <a:defRPr sz="1056"/>
            </a:lvl2pPr>
            <a:lvl3pPr marL="804928" indent="0">
              <a:buNone/>
              <a:defRPr sz="880"/>
            </a:lvl3pPr>
            <a:lvl4pPr marL="1207392" indent="0">
              <a:buNone/>
              <a:defRPr sz="792"/>
            </a:lvl4pPr>
            <a:lvl5pPr marL="1609857" indent="0">
              <a:buNone/>
              <a:defRPr sz="792"/>
            </a:lvl5pPr>
            <a:lvl6pPr marL="2012321" indent="0">
              <a:buNone/>
              <a:defRPr sz="792"/>
            </a:lvl6pPr>
            <a:lvl7pPr marL="2414784" indent="0">
              <a:buNone/>
              <a:defRPr sz="792"/>
            </a:lvl7pPr>
            <a:lvl8pPr marL="2817249" indent="0">
              <a:buNone/>
              <a:defRPr sz="792"/>
            </a:lvl8pPr>
            <a:lvl9pPr marL="3219712" indent="0">
              <a:buNone/>
              <a:defRPr sz="792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D73906-7207-4BB4-8463-9DDA4E4C50A2}" type="datetimeFigureOut">
              <a:rPr lang="en-US" smtClean="0"/>
              <a:t>3/24/2021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3CE76-F9F0-4EE8-B10F-E6024933E0A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45451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637229" y="462118"/>
            <a:ext cx="11470005" cy="19232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637229" y="2692567"/>
            <a:ext cx="11470005" cy="76155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637229" y="10695451"/>
            <a:ext cx="2973705" cy="61437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5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D73906-7207-4BB4-8463-9DDA4E4C50A2}" type="datetimeFigureOut">
              <a:rPr lang="en-US" smtClean="0"/>
              <a:t>3/24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354360" y="10695451"/>
            <a:ext cx="4035743" cy="61437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5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9133529" y="10695451"/>
            <a:ext cx="2973705" cy="61437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5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63CE76-F9F0-4EE8-B10F-E6024933E0A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29598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804928" rtl="0" eaLnBrk="1" latinLnBrk="0" hangingPunct="1">
        <a:spcBef>
          <a:spcPct val="0"/>
        </a:spcBef>
        <a:buNone/>
        <a:defRPr sz="387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1848" indent="-301848" algn="l" defTabSz="804928" rtl="0" eaLnBrk="1" latinLnBrk="0" hangingPunct="1">
        <a:spcBef>
          <a:spcPct val="20000"/>
        </a:spcBef>
        <a:buFont typeface="Arial" panose="020B0604020202020204" pitchFamily="34" charset="0"/>
        <a:buChar char="•"/>
        <a:defRPr sz="2817" kern="1200">
          <a:solidFill>
            <a:schemeClr val="tx1"/>
          </a:solidFill>
          <a:latin typeface="+mn-lt"/>
          <a:ea typeface="+mn-ea"/>
          <a:cs typeface="+mn-cs"/>
        </a:defRPr>
      </a:lvl1pPr>
      <a:lvl2pPr marL="654004" indent="-251540" algn="l" defTabSz="804928" rtl="0" eaLnBrk="1" latinLnBrk="0" hangingPunct="1">
        <a:spcBef>
          <a:spcPct val="20000"/>
        </a:spcBef>
        <a:buFont typeface="Arial" panose="020B0604020202020204" pitchFamily="34" charset="0"/>
        <a:buChar char="–"/>
        <a:defRPr sz="2465" kern="1200">
          <a:solidFill>
            <a:schemeClr val="tx1"/>
          </a:solidFill>
          <a:latin typeface="+mn-lt"/>
          <a:ea typeface="+mn-ea"/>
          <a:cs typeface="+mn-cs"/>
        </a:defRPr>
      </a:lvl2pPr>
      <a:lvl3pPr marL="1006161" indent="-201232" algn="l" defTabSz="804928" rtl="0" eaLnBrk="1" latinLnBrk="0" hangingPunct="1">
        <a:spcBef>
          <a:spcPct val="20000"/>
        </a:spcBef>
        <a:buFont typeface="Arial" panose="020B0604020202020204" pitchFamily="34" charset="0"/>
        <a:buChar char="•"/>
        <a:defRPr sz="2113" kern="1200">
          <a:solidFill>
            <a:schemeClr val="tx1"/>
          </a:solidFill>
          <a:latin typeface="+mn-lt"/>
          <a:ea typeface="+mn-ea"/>
          <a:cs typeface="+mn-cs"/>
        </a:defRPr>
      </a:lvl3pPr>
      <a:lvl4pPr marL="1408624" indent="-201232" algn="l" defTabSz="804928" rtl="0" eaLnBrk="1" latinLnBrk="0" hangingPunct="1">
        <a:spcBef>
          <a:spcPct val="20000"/>
        </a:spcBef>
        <a:buFont typeface="Arial" panose="020B0604020202020204" pitchFamily="34" charset="0"/>
        <a:buChar char="–"/>
        <a:defRPr sz="1761" kern="1200">
          <a:solidFill>
            <a:schemeClr val="tx1"/>
          </a:solidFill>
          <a:latin typeface="+mn-lt"/>
          <a:ea typeface="+mn-ea"/>
          <a:cs typeface="+mn-cs"/>
        </a:defRPr>
      </a:lvl4pPr>
      <a:lvl5pPr marL="1811088" indent="-201232" algn="l" defTabSz="804928" rtl="0" eaLnBrk="1" latinLnBrk="0" hangingPunct="1">
        <a:spcBef>
          <a:spcPct val="20000"/>
        </a:spcBef>
        <a:buFont typeface="Arial" panose="020B0604020202020204" pitchFamily="34" charset="0"/>
        <a:buChar char="»"/>
        <a:defRPr sz="1761" kern="1200">
          <a:solidFill>
            <a:schemeClr val="tx1"/>
          </a:solidFill>
          <a:latin typeface="+mn-lt"/>
          <a:ea typeface="+mn-ea"/>
          <a:cs typeface="+mn-cs"/>
        </a:defRPr>
      </a:lvl5pPr>
      <a:lvl6pPr marL="2213552" indent="-201232" algn="l" defTabSz="804928" rtl="0" eaLnBrk="1" latinLnBrk="0" hangingPunct="1">
        <a:spcBef>
          <a:spcPct val="20000"/>
        </a:spcBef>
        <a:buFont typeface="Arial" panose="020B0604020202020204" pitchFamily="34" charset="0"/>
        <a:buChar char="•"/>
        <a:defRPr sz="1761" kern="1200">
          <a:solidFill>
            <a:schemeClr val="tx1"/>
          </a:solidFill>
          <a:latin typeface="+mn-lt"/>
          <a:ea typeface="+mn-ea"/>
          <a:cs typeface="+mn-cs"/>
        </a:defRPr>
      </a:lvl6pPr>
      <a:lvl7pPr marL="2616017" indent="-201232" algn="l" defTabSz="804928" rtl="0" eaLnBrk="1" latinLnBrk="0" hangingPunct="1">
        <a:spcBef>
          <a:spcPct val="20000"/>
        </a:spcBef>
        <a:buFont typeface="Arial" panose="020B0604020202020204" pitchFamily="34" charset="0"/>
        <a:buChar char="•"/>
        <a:defRPr sz="1761" kern="1200">
          <a:solidFill>
            <a:schemeClr val="tx1"/>
          </a:solidFill>
          <a:latin typeface="+mn-lt"/>
          <a:ea typeface="+mn-ea"/>
          <a:cs typeface="+mn-cs"/>
        </a:defRPr>
      </a:lvl7pPr>
      <a:lvl8pPr marL="3018480" indent="-201232" algn="l" defTabSz="804928" rtl="0" eaLnBrk="1" latinLnBrk="0" hangingPunct="1">
        <a:spcBef>
          <a:spcPct val="20000"/>
        </a:spcBef>
        <a:buFont typeface="Arial" panose="020B0604020202020204" pitchFamily="34" charset="0"/>
        <a:buChar char="•"/>
        <a:defRPr sz="1761" kern="1200">
          <a:solidFill>
            <a:schemeClr val="tx1"/>
          </a:solidFill>
          <a:latin typeface="+mn-lt"/>
          <a:ea typeface="+mn-ea"/>
          <a:cs typeface="+mn-cs"/>
        </a:defRPr>
      </a:lvl8pPr>
      <a:lvl9pPr marL="3420944" indent="-201232" algn="l" defTabSz="804928" rtl="0" eaLnBrk="1" latinLnBrk="0" hangingPunct="1">
        <a:spcBef>
          <a:spcPct val="20000"/>
        </a:spcBef>
        <a:buFont typeface="Arial" panose="020B0604020202020204" pitchFamily="34" charset="0"/>
        <a:buChar char="•"/>
        <a:defRPr sz="176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04928" rtl="0" eaLnBrk="1" latinLnBrk="0" hangingPunct="1">
        <a:defRPr sz="1585" kern="1200">
          <a:solidFill>
            <a:schemeClr val="tx1"/>
          </a:solidFill>
          <a:latin typeface="+mn-lt"/>
          <a:ea typeface="+mn-ea"/>
          <a:cs typeface="+mn-cs"/>
        </a:defRPr>
      </a:lvl1pPr>
      <a:lvl2pPr marL="402463" algn="l" defTabSz="804928" rtl="0" eaLnBrk="1" latinLnBrk="0" hangingPunct="1">
        <a:defRPr sz="1585" kern="1200">
          <a:solidFill>
            <a:schemeClr val="tx1"/>
          </a:solidFill>
          <a:latin typeface="+mn-lt"/>
          <a:ea typeface="+mn-ea"/>
          <a:cs typeface="+mn-cs"/>
        </a:defRPr>
      </a:lvl2pPr>
      <a:lvl3pPr marL="804928" algn="l" defTabSz="804928" rtl="0" eaLnBrk="1" latinLnBrk="0" hangingPunct="1">
        <a:defRPr sz="1585" kern="1200">
          <a:solidFill>
            <a:schemeClr val="tx1"/>
          </a:solidFill>
          <a:latin typeface="+mn-lt"/>
          <a:ea typeface="+mn-ea"/>
          <a:cs typeface="+mn-cs"/>
        </a:defRPr>
      </a:lvl3pPr>
      <a:lvl4pPr marL="1207392" algn="l" defTabSz="804928" rtl="0" eaLnBrk="1" latinLnBrk="0" hangingPunct="1">
        <a:defRPr sz="1585" kern="1200">
          <a:solidFill>
            <a:schemeClr val="tx1"/>
          </a:solidFill>
          <a:latin typeface="+mn-lt"/>
          <a:ea typeface="+mn-ea"/>
          <a:cs typeface="+mn-cs"/>
        </a:defRPr>
      </a:lvl4pPr>
      <a:lvl5pPr marL="1609857" algn="l" defTabSz="804928" rtl="0" eaLnBrk="1" latinLnBrk="0" hangingPunct="1">
        <a:defRPr sz="1585" kern="1200">
          <a:solidFill>
            <a:schemeClr val="tx1"/>
          </a:solidFill>
          <a:latin typeface="+mn-lt"/>
          <a:ea typeface="+mn-ea"/>
          <a:cs typeface="+mn-cs"/>
        </a:defRPr>
      </a:lvl5pPr>
      <a:lvl6pPr marL="2012321" algn="l" defTabSz="804928" rtl="0" eaLnBrk="1" latinLnBrk="0" hangingPunct="1">
        <a:defRPr sz="1585" kern="1200">
          <a:solidFill>
            <a:schemeClr val="tx1"/>
          </a:solidFill>
          <a:latin typeface="+mn-lt"/>
          <a:ea typeface="+mn-ea"/>
          <a:cs typeface="+mn-cs"/>
        </a:defRPr>
      </a:lvl6pPr>
      <a:lvl7pPr marL="2414784" algn="l" defTabSz="804928" rtl="0" eaLnBrk="1" latinLnBrk="0" hangingPunct="1">
        <a:defRPr sz="1585" kern="1200">
          <a:solidFill>
            <a:schemeClr val="tx1"/>
          </a:solidFill>
          <a:latin typeface="+mn-lt"/>
          <a:ea typeface="+mn-ea"/>
          <a:cs typeface="+mn-cs"/>
        </a:defRPr>
      </a:lvl7pPr>
      <a:lvl8pPr marL="2817249" algn="l" defTabSz="804928" rtl="0" eaLnBrk="1" latinLnBrk="0" hangingPunct="1">
        <a:defRPr sz="1585" kern="1200">
          <a:solidFill>
            <a:schemeClr val="tx1"/>
          </a:solidFill>
          <a:latin typeface="+mn-lt"/>
          <a:ea typeface="+mn-ea"/>
          <a:cs typeface="+mn-cs"/>
        </a:defRPr>
      </a:lvl8pPr>
      <a:lvl9pPr marL="3219712" algn="l" defTabSz="804928" rtl="0" eaLnBrk="1" latinLnBrk="0" hangingPunct="1">
        <a:defRPr sz="158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13" Type="http://schemas.openxmlformats.org/officeDocument/2006/relationships/image" Target="../media/image8.png"/><Relationship Id="rId3" Type="http://schemas.openxmlformats.org/officeDocument/2006/relationships/image" Target="../media/image1.png"/><Relationship Id="rId7" Type="http://schemas.microsoft.com/office/2007/relationships/hdphoto" Target="../media/hdphoto1.wdp"/><Relationship Id="rId12" Type="http://schemas.microsoft.com/office/2007/relationships/hdphoto" Target="../media/hdphoto3.wdp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7.png"/><Relationship Id="rId5" Type="http://schemas.openxmlformats.org/officeDocument/2006/relationships/image" Target="../media/image3.png"/><Relationship Id="rId15" Type="http://schemas.openxmlformats.org/officeDocument/2006/relationships/image" Target="../media/image9.png"/><Relationship Id="rId10" Type="http://schemas.openxmlformats.org/officeDocument/2006/relationships/image" Target="../media/image6.png"/><Relationship Id="rId4" Type="http://schemas.openxmlformats.org/officeDocument/2006/relationships/image" Target="../media/image2.png"/><Relationship Id="rId9" Type="http://schemas.microsoft.com/office/2007/relationships/hdphoto" Target="../media/hdphoto2.wdp"/><Relationship Id="rId14" Type="http://schemas.microsoft.com/office/2007/relationships/hdphoto" Target="../media/hdphoto4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" name="Gruppieren 24"/>
          <p:cNvGrpSpPr/>
          <p:nvPr/>
        </p:nvGrpSpPr>
        <p:grpSpPr>
          <a:xfrm>
            <a:off x="1115641" y="172126"/>
            <a:ext cx="10801200" cy="9428360"/>
            <a:chOff x="1043633" y="1161232"/>
            <a:chExt cx="10801200" cy="9428360"/>
          </a:xfrm>
        </p:grpSpPr>
        <p:grpSp>
          <p:nvGrpSpPr>
            <p:cNvPr id="8" name="Gruppieren 7"/>
            <p:cNvGrpSpPr/>
            <p:nvPr/>
          </p:nvGrpSpPr>
          <p:grpSpPr>
            <a:xfrm>
              <a:off x="1043633" y="1161232"/>
              <a:ext cx="10801200" cy="8405955"/>
              <a:chOff x="35521" y="1252831"/>
              <a:chExt cx="12269868" cy="9548931"/>
            </a:xfrm>
          </p:grpSpPr>
          <p:sp>
            <p:nvSpPr>
              <p:cNvPr id="6" name="Textfeld 5"/>
              <p:cNvSpPr txBox="1"/>
              <p:nvPr/>
            </p:nvSpPr>
            <p:spPr>
              <a:xfrm>
                <a:off x="10418502" y="10419796"/>
                <a:ext cx="1886887" cy="3819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585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Online </a:t>
                </a:r>
                <a:r>
                  <a:rPr lang="de-DE" sz="1585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Figure</a:t>
                </a:r>
                <a:r>
                  <a:rPr lang="de-DE" sz="1585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1</a:t>
                </a:r>
                <a:endParaRPr lang="en-US" sz="1761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" name="Textfeld 6"/>
              <p:cNvSpPr txBox="1"/>
              <p:nvPr/>
            </p:nvSpPr>
            <p:spPr>
              <a:xfrm>
                <a:off x="35521" y="1255905"/>
                <a:ext cx="2447745" cy="28946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056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Full</a:t>
                </a:r>
                <a:r>
                  <a:rPr lang="de-DE" sz="1056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1056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nedited</a:t>
                </a:r>
                <a:r>
                  <a:rPr lang="de-DE" sz="1056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1056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l</a:t>
                </a:r>
                <a:r>
                  <a:rPr lang="de-DE" sz="1056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1056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for</a:t>
                </a:r>
                <a:r>
                  <a:rPr lang="de-DE" sz="1056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1056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Figure</a:t>
                </a:r>
                <a:r>
                  <a:rPr lang="de-DE" sz="1056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3 a</a:t>
                </a:r>
                <a:endParaRPr lang="en-US" sz="1056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" name="Textfeld 1"/>
              <p:cNvSpPr txBox="1"/>
              <p:nvPr/>
            </p:nvSpPr>
            <p:spPr>
              <a:xfrm>
                <a:off x="35522" y="4158524"/>
                <a:ext cx="2901165" cy="28946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056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Full</a:t>
                </a:r>
                <a:r>
                  <a:rPr lang="de-DE" sz="1056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1056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nedited</a:t>
                </a:r>
                <a:r>
                  <a:rPr lang="de-DE" sz="1056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1056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l</a:t>
                </a:r>
                <a:r>
                  <a:rPr lang="de-DE" sz="1056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1056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for</a:t>
                </a:r>
                <a:r>
                  <a:rPr lang="de-DE" sz="1056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1056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Figure</a:t>
                </a:r>
                <a:r>
                  <a:rPr lang="de-DE" sz="1056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3 b </a:t>
                </a:r>
                <a:r>
                  <a:rPr lang="de-DE" sz="1056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nd</a:t>
                </a:r>
                <a:r>
                  <a:rPr lang="de-DE" sz="1056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d</a:t>
                </a:r>
                <a:endParaRPr lang="en-US" sz="1056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4" name="Grafik 23"/>
              <p:cNvPicPr>
                <a:picLocks noChangeAspect="1"/>
              </p:cNvPicPr>
              <p:nvPr/>
            </p:nvPicPr>
            <p:blipFill rotWithShape="1">
              <a:blip r:embed="rId3"/>
              <a:srcRect l="3932" t="19900" r="69687" b="19900"/>
              <a:stretch/>
            </p:blipFill>
            <p:spPr>
              <a:xfrm>
                <a:off x="126816" y="1614262"/>
                <a:ext cx="3221788" cy="2067714"/>
              </a:xfrm>
              <a:prstGeom prst="rect">
                <a:avLst/>
              </a:prstGeom>
            </p:spPr>
          </p:pic>
          <p:sp>
            <p:nvSpPr>
              <p:cNvPr id="57" name="Textfeld 56"/>
              <p:cNvSpPr txBox="1"/>
              <p:nvPr/>
            </p:nvSpPr>
            <p:spPr>
              <a:xfrm>
                <a:off x="3362156" y="1252831"/>
                <a:ext cx="3030455" cy="28946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056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Full</a:t>
                </a:r>
                <a:r>
                  <a:rPr lang="de-DE" sz="1056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1056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nedited</a:t>
                </a:r>
                <a:r>
                  <a:rPr lang="de-DE" sz="1056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1056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embrane</a:t>
                </a:r>
                <a:r>
                  <a:rPr lang="de-DE" sz="1056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1056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for</a:t>
                </a:r>
                <a:r>
                  <a:rPr lang="de-DE" sz="1056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1056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Figure</a:t>
                </a:r>
                <a:r>
                  <a:rPr lang="de-DE" sz="1056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3 a</a:t>
                </a:r>
                <a:endParaRPr lang="en-US" sz="1056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59" name="Grafik 58"/>
              <p:cNvPicPr>
                <a:picLocks noChangeAspect="1"/>
              </p:cNvPicPr>
              <p:nvPr/>
            </p:nvPicPr>
            <p:blipFill rotWithShape="1">
              <a:blip r:embed="rId4"/>
              <a:srcRect l="3935" t="18315" r="69507" b="17988"/>
              <a:stretch/>
            </p:blipFill>
            <p:spPr>
              <a:xfrm>
                <a:off x="107529" y="4627652"/>
                <a:ext cx="3240360" cy="2185899"/>
              </a:xfrm>
              <a:prstGeom prst="rect">
                <a:avLst/>
              </a:prstGeom>
            </p:spPr>
          </p:pic>
          <p:pic>
            <p:nvPicPr>
              <p:cNvPr id="60" name="Grafik 59"/>
              <p:cNvPicPr>
                <a:picLocks noChangeAspect="1"/>
              </p:cNvPicPr>
              <p:nvPr/>
            </p:nvPicPr>
            <p:blipFill rotWithShape="1">
              <a:blip r:embed="rId5"/>
              <a:srcRect l="4522" t="20601" r="68113" b="17101"/>
              <a:stretch/>
            </p:blipFill>
            <p:spPr>
              <a:xfrm>
                <a:off x="3592654" y="4664760"/>
                <a:ext cx="3211621" cy="2056362"/>
              </a:xfrm>
              <a:prstGeom prst="rect">
                <a:avLst/>
              </a:prstGeom>
            </p:spPr>
          </p:pic>
          <p:grpSp>
            <p:nvGrpSpPr>
              <p:cNvPr id="43" name="Gruppieren 42"/>
              <p:cNvGrpSpPr/>
              <p:nvPr/>
            </p:nvGrpSpPr>
            <p:grpSpPr>
              <a:xfrm>
                <a:off x="7236321" y="1253075"/>
                <a:ext cx="5040560" cy="2412802"/>
                <a:chOff x="6948289" y="199673"/>
                <a:chExt cx="5040560" cy="2412802"/>
              </a:xfrm>
            </p:grpSpPr>
            <p:pic>
              <p:nvPicPr>
                <p:cNvPr id="5" name="Grafik 4"/>
                <p:cNvPicPr>
                  <a:picLocks noChangeAspect="1"/>
                </p:cNvPicPr>
                <p:nvPr/>
              </p:nvPicPr>
              <p:blipFill>
                <a:blip r:embed="rId6" cstate="print">
                  <a:extLst>
                    <a:ext uri="{BEBA8EAE-BF5A-486C-A8C5-ECC9F3942E4B}">
                      <a14:imgProps xmlns:a14="http://schemas.microsoft.com/office/drawing/2010/main">
                        <a14:imgLayer r:embed="rId7">
                          <a14:imgEffect>
                            <a14:sharpenSoften amount="100000"/>
                          </a14:imgEffect>
                          <a14:imgEffect>
                            <a14:colorTemperature colorTemp="7200"/>
                          </a14:imgEffect>
                          <a14:imgEffect>
                            <a14:brightnessContrast bright="-7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7310132" y="648666"/>
                  <a:ext cx="3615374" cy="1761190"/>
                </a:xfrm>
                <a:prstGeom prst="rect">
                  <a:avLst/>
                </a:prstGeom>
              </p:spPr>
            </p:pic>
            <p:sp>
              <p:nvSpPr>
                <p:cNvPr id="9" name="Textfeld 8"/>
                <p:cNvSpPr txBox="1"/>
                <p:nvPr/>
              </p:nvSpPr>
              <p:spPr>
                <a:xfrm>
                  <a:off x="6949267" y="805770"/>
                  <a:ext cx="444681" cy="27409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68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60</a:t>
                  </a:r>
                  <a:endParaRPr lang="en-US" sz="968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" name="Textfeld 9"/>
                <p:cNvSpPr txBox="1"/>
                <p:nvPr/>
              </p:nvSpPr>
              <p:spPr>
                <a:xfrm>
                  <a:off x="6951413" y="927823"/>
                  <a:ext cx="543204" cy="27409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968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60</a:t>
                  </a:r>
                  <a:endParaRPr lang="en-US" sz="968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" name="Textfeld 10"/>
                <p:cNvSpPr txBox="1"/>
                <p:nvPr/>
              </p:nvSpPr>
              <p:spPr>
                <a:xfrm>
                  <a:off x="6948289" y="1064214"/>
                  <a:ext cx="444681" cy="27409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68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25</a:t>
                  </a:r>
                  <a:endParaRPr lang="en-US" sz="968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" name="Textfeld 11"/>
                <p:cNvSpPr txBox="1"/>
                <p:nvPr/>
              </p:nvSpPr>
              <p:spPr>
                <a:xfrm>
                  <a:off x="7026575" y="1214330"/>
                  <a:ext cx="366378" cy="27409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68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90</a:t>
                  </a:r>
                  <a:endParaRPr lang="en-US" sz="968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" name="Textfeld 12"/>
                <p:cNvSpPr txBox="1"/>
                <p:nvPr/>
              </p:nvSpPr>
              <p:spPr>
                <a:xfrm>
                  <a:off x="7029912" y="1437484"/>
                  <a:ext cx="366378" cy="27409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68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0</a:t>
                  </a:r>
                  <a:endParaRPr lang="en-US" sz="968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" name="Textfeld 13"/>
                <p:cNvSpPr txBox="1"/>
                <p:nvPr/>
              </p:nvSpPr>
              <p:spPr>
                <a:xfrm>
                  <a:off x="7026575" y="1738892"/>
                  <a:ext cx="366378" cy="27409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68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</a:t>
                  </a:r>
                  <a:endParaRPr lang="en-US" sz="968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" name="Textfeld 14"/>
                <p:cNvSpPr txBox="1"/>
                <p:nvPr/>
              </p:nvSpPr>
              <p:spPr>
                <a:xfrm>
                  <a:off x="7026575" y="2169179"/>
                  <a:ext cx="468352" cy="44329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68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8</a:t>
                  </a:r>
                </a:p>
                <a:p>
                  <a:r>
                    <a:rPr lang="de-DE" sz="968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kDa</a:t>
                  </a:r>
                  <a:endParaRPr lang="en-US" sz="968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26" name="Gerader Verbinder 25"/>
                <p:cNvCxnSpPr/>
                <p:nvPr/>
              </p:nvCxnSpPr>
              <p:spPr>
                <a:xfrm>
                  <a:off x="7321911" y="1524746"/>
                  <a:ext cx="3441051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7" name="Gerader Verbinder 26"/>
                <p:cNvCxnSpPr>
                  <a:endCxn id="31" idx="1"/>
                </p:cNvCxnSpPr>
                <p:nvPr/>
              </p:nvCxnSpPr>
              <p:spPr>
                <a:xfrm flipV="1">
                  <a:off x="7335057" y="1933589"/>
                  <a:ext cx="4131200" cy="17261"/>
                </a:xfrm>
                <a:prstGeom prst="line">
                  <a:avLst/>
                </a:prstGeom>
                <a:ln>
                  <a:solidFill>
                    <a:schemeClr val="tx1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0" name="Textfeld 29"/>
                <p:cNvSpPr txBox="1"/>
                <p:nvPr/>
              </p:nvSpPr>
              <p:spPr>
                <a:xfrm>
                  <a:off x="11447639" y="1381480"/>
                  <a:ext cx="421007" cy="27409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68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ut</a:t>
                  </a:r>
                  <a:endParaRPr lang="en-US" sz="968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" name="Textfeld 30"/>
                <p:cNvSpPr txBox="1"/>
                <p:nvPr/>
              </p:nvSpPr>
              <p:spPr>
                <a:xfrm>
                  <a:off x="11466257" y="1796542"/>
                  <a:ext cx="522592" cy="27409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968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ut</a:t>
                  </a:r>
                  <a:endParaRPr lang="en-US" sz="968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" name="Rechteck 37"/>
                <p:cNvSpPr/>
                <p:nvPr/>
              </p:nvSpPr>
              <p:spPr>
                <a:xfrm>
                  <a:off x="7374733" y="1540283"/>
                  <a:ext cx="3478910" cy="373469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585"/>
                </a:p>
              </p:txBody>
            </p:sp>
            <p:sp>
              <p:nvSpPr>
                <p:cNvPr id="39" name="Textfeld 38"/>
                <p:cNvSpPr txBox="1"/>
                <p:nvPr/>
              </p:nvSpPr>
              <p:spPr>
                <a:xfrm>
                  <a:off x="10836722" y="1567825"/>
                  <a:ext cx="848935" cy="28946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1056" dirty="0" smtClean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KT1/2/3</a:t>
                  </a:r>
                  <a:endParaRPr lang="en-US" sz="1056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8" name="Textfeld 57"/>
                <p:cNvSpPr txBox="1"/>
                <p:nvPr/>
              </p:nvSpPr>
              <p:spPr>
                <a:xfrm>
                  <a:off x="7236321" y="199673"/>
                  <a:ext cx="2824685" cy="47403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1056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embrane </a:t>
                  </a:r>
                  <a:r>
                    <a:rPr lang="de-DE" sz="1056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fragments</a:t>
                  </a:r>
                  <a:r>
                    <a:rPr lang="de-DE" sz="1056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de-DE" sz="1056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for</a:t>
                  </a:r>
                  <a:r>
                    <a:rPr lang="de-DE" sz="1056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de-DE" sz="1056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Figure</a:t>
                  </a:r>
                  <a:r>
                    <a:rPr lang="de-DE" sz="1056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 a </a:t>
                  </a:r>
                </a:p>
                <a:p>
                  <a:r>
                    <a:rPr lang="de-DE" sz="1056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fter Ponceau S </a:t>
                  </a:r>
                  <a:r>
                    <a:rPr lang="de-DE" sz="1056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taining</a:t>
                  </a:r>
                  <a:endParaRPr lang="en-US" sz="1056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55" name="Gerader Verbinder 54"/>
                <p:cNvCxnSpPr/>
                <p:nvPr/>
              </p:nvCxnSpPr>
              <p:spPr>
                <a:xfrm>
                  <a:off x="7321911" y="1524746"/>
                  <a:ext cx="4144347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62" name="Textfeld 61"/>
              <p:cNvSpPr txBox="1"/>
              <p:nvPr/>
            </p:nvSpPr>
            <p:spPr>
              <a:xfrm>
                <a:off x="3419897" y="4160288"/>
                <a:ext cx="3500265" cy="28946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056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Full</a:t>
                </a:r>
                <a:r>
                  <a:rPr lang="de-DE" sz="1056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1056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nedited</a:t>
                </a:r>
                <a:r>
                  <a:rPr lang="de-DE" sz="1056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1056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embrane</a:t>
                </a:r>
                <a:r>
                  <a:rPr lang="de-DE" sz="1056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1056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for</a:t>
                </a:r>
                <a:r>
                  <a:rPr lang="de-DE" sz="1056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1056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Figure</a:t>
                </a:r>
                <a:r>
                  <a:rPr lang="de-DE" sz="1056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3 b </a:t>
                </a:r>
                <a:r>
                  <a:rPr lang="de-DE" sz="1056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nd</a:t>
                </a:r>
                <a:r>
                  <a:rPr lang="de-DE" sz="1056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d</a:t>
                </a:r>
                <a:endParaRPr lang="en-US" sz="1056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4" name="Grafik 3"/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sharpenSoften amount="100000"/>
                        </a14:imgEffect>
                        <a14:imgEffect>
                          <a14:brightnessContrast bright="-7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618482" y="4640401"/>
                <a:ext cx="3670426" cy="2180600"/>
              </a:xfrm>
              <a:prstGeom prst="rect">
                <a:avLst/>
              </a:prstGeom>
            </p:spPr>
          </p:pic>
          <p:sp>
            <p:nvSpPr>
              <p:cNvPr id="17" name="Textfeld 16"/>
              <p:cNvSpPr txBox="1"/>
              <p:nvPr/>
            </p:nvSpPr>
            <p:spPr>
              <a:xfrm>
                <a:off x="7240084" y="4941343"/>
                <a:ext cx="654226" cy="27409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968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60</a:t>
                </a:r>
                <a:endParaRPr lang="en-US" sz="968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45" name="Gruppieren 44"/>
              <p:cNvGrpSpPr/>
              <p:nvPr/>
            </p:nvGrpSpPr>
            <p:grpSpPr>
              <a:xfrm>
                <a:off x="7246050" y="4765068"/>
                <a:ext cx="586312" cy="2228937"/>
                <a:chOff x="7236321" y="3596591"/>
                <a:chExt cx="586312" cy="2228937"/>
              </a:xfrm>
            </p:grpSpPr>
            <p:sp>
              <p:nvSpPr>
                <p:cNvPr id="16" name="Textfeld 15"/>
                <p:cNvSpPr txBox="1"/>
                <p:nvPr/>
              </p:nvSpPr>
              <p:spPr>
                <a:xfrm>
                  <a:off x="7237499" y="3596591"/>
                  <a:ext cx="444681" cy="27409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68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60</a:t>
                  </a:r>
                  <a:endParaRPr lang="en-US" sz="968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" name="Textfeld 17"/>
                <p:cNvSpPr txBox="1"/>
                <p:nvPr/>
              </p:nvSpPr>
              <p:spPr>
                <a:xfrm>
                  <a:off x="7236321" y="3945264"/>
                  <a:ext cx="444681" cy="27409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68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25</a:t>
                  </a:r>
                  <a:endParaRPr lang="en-US" sz="968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" name="Textfeld 18"/>
                <p:cNvSpPr txBox="1"/>
                <p:nvPr/>
              </p:nvSpPr>
              <p:spPr>
                <a:xfrm>
                  <a:off x="7330607" y="4129053"/>
                  <a:ext cx="366378" cy="27409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68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90</a:t>
                  </a:r>
                  <a:endParaRPr lang="en-US" sz="968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" name="Textfeld 19"/>
                <p:cNvSpPr txBox="1"/>
                <p:nvPr/>
              </p:nvSpPr>
              <p:spPr>
                <a:xfrm>
                  <a:off x="7334626" y="4348930"/>
                  <a:ext cx="366378" cy="27409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68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0</a:t>
                  </a:r>
                  <a:endParaRPr lang="en-US" sz="968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" name="Textfeld 20"/>
                <p:cNvSpPr txBox="1"/>
                <p:nvPr/>
              </p:nvSpPr>
              <p:spPr>
                <a:xfrm>
                  <a:off x="7330607" y="4708970"/>
                  <a:ext cx="366378" cy="27409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68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</a:t>
                  </a:r>
                  <a:endParaRPr lang="en-US" sz="968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" name="Textfeld 21"/>
                <p:cNvSpPr txBox="1"/>
                <p:nvPr/>
              </p:nvSpPr>
              <p:spPr>
                <a:xfrm>
                  <a:off x="7330607" y="5213026"/>
                  <a:ext cx="492026" cy="61250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68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8</a:t>
                  </a:r>
                </a:p>
                <a:p>
                  <a:endParaRPr lang="de-DE" sz="968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r>
                    <a:rPr lang="de-DE" sz="968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kDA</a:t>
                  </a:r>
                  <a:endParaRPr lang="en-US" sz="968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cxnSp>
            <p:nvCxnSpPr>
              <p:cNvPr id="28" name="Gerader Verbinder 27"/>
              <p:cNvCxnSpPr/>
              <p:nvPr/>
            </p:nvCxnSpPr>
            <p:spPr>
              <a:xfrm>
                <a:off x="7662767" y="5582197"/>
                <a:ext cx="4144347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Gerader Verbinder 28"/>
              <p:cNvCxnSpPr/>
              <p:nvPr/>
            </p:nvCxnSpPr>
            <p:spPr>
              <a:xfrm>
                <a:off x="7655274" y="5990242"/>
                <a:ext cx="4144347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2" name="Textfeld 31"/>
              <p:cNvSpPr txBox="1"/>
              <p:nvPr/>
            </p:nvSpPr>
            <p:spPr>
              <a:xfrm>
                <a:off x="11833048" y="5421360"/>
                <a:ext cx="421007" cy="27409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968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ut</a:t>
                </a:r>
                <a:endParaRPr lang="en-US" sz="968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Textfeld 32"/>
              <p:cNvSpPr txBox="1"/>
              <p:nvPr/>
            </p:nvSpPr>
            <p:spPr>
              <a:xfrm>
                <a:off x="11833049" y="5844451"/>
                <a:ext cx="421007" cy="27409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968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ut</a:t>
                </a:r>
                <a:endParaRPr lang="en-US" sz="968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Rechteck 33"/>
              <p:cNvSpPr/>
              <p:nvPr/>
            </p:nvSpPr>
            <p:spPr>
              <a:xfrm>
                <a:off x="7742217" y="6009079"/>
                <a:ext cx="3469764" cy="689586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585"/>
              </a:p>
            </p:txBody>
          </p:sp>
          <p:sp>
            <p:nvSpPr>
              <p:cNvPr id="35" name="Textfeld 34"/>
              <p:cNvSpPr txBox="1"/>
              <p:nvPr/>
            </p:nvSpPr>
            <p:spPr>
              <a:xfrm>
                <a:off x="11268770" y="6144967"/>
                <a:ext cx="737856" cy="28946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056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RK1/2</a:t>
                </a:r>
                <a:endParaRPr lang="en-US" sz="1056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" name="Rechteck 35"/>
              <p:cNvSpPr/>
              <p:nvPr/>
            </p:nvSpPr>
            <p:spPr>
              <a:xfrm>
                <a:off x="7742218" y="5151571"/>
                <a:ext cx="3469764" cy="379121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585"/>
              </a:p>
            </p:txBody>
          </p:sp>
          <p:sp>
            <p:nvSpPr>
              <p:cNvPr id="37" name="Textfeld 36"/>
              <p:cNvSpPr txBox="1"/>
              <p:nvPr/>
            </p:nvSpPr>
            <p:spPr>
              <a:xfrm>
                <a:off x="11268769" y="5130473"/>
                <a:ext cx="688690" cy="28946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056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TAT3</a:t>
                </a:r>
                <a:endParaRPr lang="en-US" sz="1056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" name="Textfeld 62"/>
              <p:cNvSpPr txBox="1"/>
              <p:nvPr/>
            </p:nvSpPr>
            <p:spPr>
              <a:xfrm>
                <a:off x="7485766" y="4146369"/>
                <a:ext cx="3278106" cy="47403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056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embrane </a:t>
                </a:r>
                <a:r>
                  <a:rPr lang="de-DE" sz="1056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fragments</a:t>
                </a:r>
                <a:r>
                  <a:rPr lang="de-DE" sz="1056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1056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for</a:t>
                </a:r>
                <a:r>
                  <a:rPr lang="de-DE" sz="1056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1056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Figure</a:t>
                </a:r>
                <a:r>
                  <a:rPr lang="de-DE" sz="1056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3 b </a:t>
                </a:r>
                <a:r>
                  <a:rPr lang="de-DE" sz="1056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nd</a:t>
                </a:r>
                <a:r>
                  <a:rPr lang="de-DE" sz="1056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d </a:t>
                </a:r>
              </a:p>
              <a:p>
                <a:r>
                  <a:rPr lang="de-DE" sz="1056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fter Ponceau S </a:t>
                </a:r>
                <a:r>
                  <a:rPr lang="de-DE" sz="1056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taining</a:t>
                </a:r>
                <a:endParaRPr lang="en-US" sz="1056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3" name="Grafik 2"/>
              <p:cNvPicPr>
                <a:picLocks noChangeAspect="1"/>
              </p:cNvPicPr>
              <p:nvPr/>
            </p:nvPicPr>
            <p:blipFill rotWithShape="1">
              <a:blip r:embed="rId10"/>
              <a:srcRect l="3144" t="15001" r="69294" b="24100"/>
              <a:stretch/>
            </p:blipFill>
            <p:spPr>
              <a:xfrm>
                <a:off x="3464158" y="1604716"/>
                <a:ext cx="3340117" cy="2075644"/>
              </a:xfrm>
              <a:prstGeom prst="rect">
                <a:avLst/>
              </a:prstGeom>
            </p:spPr>
          </p:pic>
        </p:grpSp>
        <p:sp>
          <p:nvSpPr>
            <p:cNvPr id="23" name="Rechteck 22"/>
            <p:cNvSpPr/>
            <p:nvPr/>
          </p:nvSpPr>
          <p:spPr>
            <a:xfrm>
              <a:off x="1043633" y="9635485"/>
              <a:ext cx="10776103" cy="95410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Online Figure 1: Full unedited gels for Figure 3 </a:t>
              </a:r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-d </a:t>
              </a: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fter </a:t>
              </a: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onceau</a:t>
              </a: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S staining for validation of equal protein loading. </a:t>
              </a: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AKT1/2/3: protein kinase B; ERK1/2: mitogen extracellular-regulated kinase 1/2; </a:t>
              </a:r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SK-3</a:t>
              </a:r>
              <a:r>
                <a:rPr lang="el-G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de-DE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: </a:t>
              </a:r>
              <a:r>
                <a:rPr lang="de-DE" sz="14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glycogen</a:t>
              </a:r>
              <a:r>
                <a:rPr lang="de-DE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4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ynthase</a:t>
              </a:r>
              <a:r>
                <a:rPr lang="de-DE" sz="1400" smtClean="0">
                  <a:latin typeface="Arial" panose="020B0604020202020204" pitchFamily="34" charset="0"/>
                  <a:cs typeface="Arial" panose="020B0604020202020204" pitchFamily="34" charset="0"/>
                </a:rPr>
                <a:t> kinase</a:t>
              </a:r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de-DE" sz="1400" smtClean="0">
                  <a:latin typeface="Arial" panose="020B0604020202020204" pitchFamily="34" charset="0"/>
                  <a:cs typeface="Arial" panose="020B0604020202020204" pitchFamily="34" charset="0"/>
                </a:rPr>
                <a:t>3 </a:t>
              </a:r>
              <a:r>
                <a:rPr lang="el-G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de-DE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; </a:t>
              </a:r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TAT3</a:t>
              </a: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: signal transducer and activator of transcription 3; dotted lines indicate membrane cuts; red squares indicate the areas chosen for fluorescence </a:t>
              </a:r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ignal intensity analysis</a:t>
              </a: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. </a:t>
              </a:r>
            </a:p>
          </p:txBody>
        </p:sp>
      </p:grpSp>
      <p:sp>
        <p:nvSpPr>
          <p:cNvPr id="49" name="Textfeld 48"/>
          <p:cNvSpPr txBox="1"/>
          <p:nvPr/>
        </p:nvSpPr>
        <p:spPr>
          <a:xfrm>
            <a:off x="1104492" y="5363174"/>
            <a:ext cx="2266967" cy="2548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6" b="1" dirty="0" err="1">
                <a:latin typeface="Arial" panose="020B0604020202020204" pitchFamily="34" charset="0"/>
                <a:cs typeface="Arial" panose="020B0604020202020204" pitchFamily="34" charset="0"/>
              </a:rPr>
              <a:t>Full</a:t>
            </a:r>
            <a:r>
              <a:rPr lang="de-DE" sz="1056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6" b="1" dirty="0" err="1">
                <a:latin typeface="Arial" panose="020B0604020202020204" pitchFamily="34" charset="0"/>
                <a:cs typeface="Arial" panose="020B0604020202020204" pitchFamily="34" charset="0"/>
              </a:rPr>
              <a:t>unedited</a:t>
            </a:r>
            <a:r>
              <a:rPr lang="de-DE" sz="1056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6" b="1" dirty="0" err="1">
                <a:latin typeface="Arial" panose="020B0604020202020204" pitchFamily="34" charset="0"/>
                <a:cs typeface="Arial" panose="020B0604020202020204" pitchFamily="34" charset="0"/>
              </a:rPr>
              <a:t>gel</a:t>
            </a:r>
            <a:r>
              <a:rPr lang="de-DE" sz="1056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6" b="1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056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6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056" b="1" dirty="0">
                <a:latin typeface="Arial" panose="020B0604020202020204" pitchFamily="34" charset="0"/>
                <a:cs typeface="Arial" panose="020B0604020202020204" pitchFamily="34" charset="0"/>
              </a:rPr>
              <a:t> 3 </a:t>
            </a:r>
            <a:r>
              <a:rPr lang="de-DE" sz="1056" b="1" dirty="0" smtClean="0">
                <a:latin typeface="Arial" panose="020B0604020202020204" pitchFamily="34" charset="0"/>
                <a:cs typeface="Arial" panose="020B0604020202020204" pitchFamily="34" charset="0"/>
              </a:rPr>
              <a:t>c </a:t>
            </a:r>
            <a:endParaRPr lang="en-US" sz="1056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feld 49"/>
          <p:cNvSpPr txBox="1"/>
          <p:nvPr/>
        </p:nvSpPr>
        <p:spPr>
          <a:xfrm>
            <a:off x="4078975" y="5364727"/>
            <a:ext cx="2653290" cy="2548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6" b="1" dirty="0" err="1">
                <a:latin typeface="Arial" panose="020B0604020202020204" pitchFamily="34" charset="0"/>
                <a:cs typeface="Arial" panose="020B0604020202020204" pitchFamily="34" charset="0"/>
              </a:rPr>
              <a:t>Full</a:t>
            </a:r>
            <a:r>
              <a:rPr lang="de-DE" sz="1056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6" b="1" dirty="0" err="1">
                <a:latin typeface="Arial" panose="020B0604020202020204" pitchFamily="34" charset="0"/>
                <a:cs typeface="Arial" panose="020B0604020202020204" pitchFamily="34" charset="0"/>
              </a:rPr>
              <a:t>unedited</a:t>
            </a:r>
            <a:r>
              <a:rPr lang="de-DE" sz="1056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6" b="1" dirty="0" err="1">
                <a:latin typeface="Arial" panose="020B0604020202020204" pitchFamily="34" charset="0"/>
                <a:cs typeface="Arial" panose="020B0604020202020204" pitchFamily="34" charset="0"/>
              </a:rPr>
              <a:t>membrane</a:t>
            </a:r>
            <a:r>
              <a:rPr lang="de-DE" sz="1056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6" b="1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056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6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056" b="1" dirty="0">
                <a:latin typeface="Arial" panose="020B0604020202020204" pitchFamily="34" charset="0"/>
                <a:cs typeface="Arial" panose="020B0604020202020204" pitchFamily="34" charset="0"/>
              </a:rPr>
              <a:t> 3 c</a:t>
            </a:r>
            <a:endParaRPr lang="en-US" sz="1056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feld 50"/>
          <p:cNvSpPr txBox="1"/>
          <p:nvPr/>
        </p:nvSpPr>
        <p:spPr>
          <a:xfrm>
            <a:off x="7569663" y="5352474"/>
            <a:ext cx="2411238" cy="4172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6" b="1" dirty="0">
                <a:latin typeface="Arial" panose="020B0604020202020204" pitchFamily="34" charset="0"/>
                <a:cs typeface="Arial" panose="020B0604020202020204" pitchFamily="34" charset="0"/>
              </a:rPr>
              <a:t>Membrane </a:t>
            </a:r>
            <a:r>
              <a:rPr lang="de-DE" sz="1056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ragment</a:t>
            </a:r>
            <a:r>
              <a:rPr lang="de-DE" sz="1056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6" b="1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056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6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056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6" b="1" dirty="0" smtClean="0">
                <a:latin typeface="Arial" panose="020B0604020202020204" pitchFamily="34" charset="0"/>
                <a:cs typeface="Arial" panose="020B0604020202020204" pitchFamily="34" charset="0"/>
              </a:rPr>
              <a:t>3 c </a:t>
            </a:r>
            <a:endParaRPr lang="de-DE" sz="1056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de-DE" sz="1056" b="1" dirty="0">
                <a:latin typeface="Arial" panose="020B0604020202020204" pitchFamily="34" charset="0"/>
                <a:cs typeface="Arial" panose="020B0604020202020204" pitchFamily="34" charset="0"/>
              </a:rPr>
              <a:t>after Ponceau S </a:t>
            </a:r>
            <a:r>
              <a:rPr lang="de-DE" sz="1056" b="1" dirty="0" err="1">
                <a:latin typeface="Arial" panose="020B0604020202020204" pitchFamily="34" charset="0"/>
                <a:cs typeface="Arial" panose="020B0604020202020204" pitchFamily="34" charset="0"/>
              </a:rPr>
              <a:t>staining</a:t>
            </a:r>
            <a:endParaRPr lang="en-US" sz="1056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1" name="Grafik 40"/>
          <p:cNvPicPr>
            <a:picLocks noChangeAspect="1"/>
          </p:cNvPicPr>
          <p:nvPr/>
        </p:nvPicPr>
        <p:blipFill rotWithShape="1"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-18000" contrast="25000"/>
                    </a14:imgEffect>
                  </a14:imgLayer>
                </a14:imgProps>
              </a:ext>
            </a:extLst>
          </a:blip>
          <a:srcRect l="-15156" r="5527" b="7766"/>
          <a:stretch/>
        </p:blipFill>
        <p:spPr>
          <a:xfrm>
            <a:off x="3707929" y="5913785"/>
            <a:ext cx="3384376" cy="1866437"/>
          </a:xfrm>
          <a:prstGeom prst="rect">
            <a:avLst/>
          </a:prstGeom>
        </p:spPr>
      </p:pic>
      <p:pic>
        <p:nvPicPr>
          <p:cNvPr id="42" name="Grafik 41"/>
          <p:cNvPicPr>
            <a:picLocks noChangeAspect="1"/>
          </p:cNvPicPr>
          <p:nvPr/>
        </p:nvPicPr>
        <p:blipFill rotWithShape="1">
          <a:blip r:embed="rId13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contrast="-50000"/>
                    </a14:imgEffect>
                  </a14:imgLayer>
                </a14:imgProps>
              </a:ext>
            </a:extLst>
          </a:blip>
          <a:srcRect l="7628" t="30521" r="66172" b="19163"/>
          <a:stretch/>
        </p:blipFill>
        <p:spPr>
          <a:xfrm>
            <a:off x="1125983" y="5985793"/>
            <a:ext cx="2797970" cy="1872208"/>
          </a:xfrm>
          <a:prstGeom prst="rect">
            <a:avLst/>
          </a:prstGeom>
        </p:spPr>
      </p:pic>
      <p:grpSp>
        <p:nvGrpSpPr>
          <p:cNvPr id="46" name="Gruppieren 45"/>
          <p:cNvGrpSpPr/>
          <p:nvPr/>
        </p:nvGrpSpPr>
        <p:grpSpPr>
          <a:xfrm>
            <a:off x="7543013" y="7081460"/>
            <a:ext cx="3384376" cy="897182"/>
            <a:chOff x="7524353" y="7081460"/>
            <a:chExt cx="3384376" cy="897182"/>
          </a:xfrm>
        </p:grpSpPr>
        <p:pic>
          <p:nvPicPr>
            <p:cNvPr id="44" name="Grafik 43"/>
            <p:cNvPicPr>
              <a:picLocks noChangeAspect="1"/>
            </p:cNvPicPr>
            <p:nvPr/>
          </p:nvPicPr>
          <p:blipFill rotWithShape="1">
            <a:blip r:embed="rId15"/>
            <a:srcRect l="6497" t="37920" r="56688" b="38893"/>
            <a:stretch/>
          </p:blipFill>
          <p:spPr>
            <a:xfrm>
              <a:off x="7878887" y="7147792"/>
              <a:ext cx="3029842" cy="656040"/>
            </a:xfrm>
            <a:prstGeom prst="rect">
              <a:avLst/>
            </a:prstGeom>
          </p:spPr>
        </p:pic>
        <p:sp>
          <p:nvSpPr>
            <p:cNvPr id="56" name="Textfeld 55"/>
            <p:cNvSpPr txBox="1"/>
            <p:nvPr/>
          </p:nvSpPr>
          <p:spPr>
            <a:xfrm>
              <a:off x="7524353" y="7081460"/>
              <a:ext cx="322524" cy="2412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68" b="1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lang="en-US" sz="968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Textfeld 60"/>
            <p:cNvSpPr txBox="1"/>
            <p:nvPr/>
          </p:nvSpPr>
          <p:spPr>
            <a:xfrm>
              <a:off x="7532759" y="7588407"/>
              <a:ext cx="433132" cy="39023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68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  <a:endParaRPr lang="de-DE" sz="968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de-DE" sz="968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968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Textfeld 63"/>
            <p:cNvSpPr txBox="1"/>
            <p:nvPr/>
          </p:nvSpPr>
          <p:spPr>
            <a:xfrm>
              <a:off x="7526345" y="7263523"/>
              <a:ext cx="322524" cy="2412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68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8</a:t>
              </a:r>
              <a:endParaRPr lang="en-US" sz="968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65" name="Gerader Verbinder 64"/>
          <p:cNvCxnSpPr/>
          <p:nvPr/>
        </p:nvCxnSpPr>
        <p:spPr>
          <a:xfrm>
            <a:off x="7812385" y="7138170"/>
            <a:ext cx="3648281" cy="0"/>
          </a:xfrm>
          <a:prstGeom prst="line">
            <a:avLst/>
          </a:prstGeom>
          <a:ln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Textfeld 65"/>
          <p:cNvSpPr txBox="1"/>
          <p:nvPr/>
        </p:nvSpPr>
        <p:spPr>
          <a:xfrm>
            <a:off x="11490093" y="7009830"/>
            <a:ext cx="370614" cy="2412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68" b="1" dirty="0" err="1">
                <a:latin typeface="Arial" panose="020B0604020202020204" pitchFamily="34" charset="0"/>
                <a:cs typeface="Arial" panose="020B0604020202020204" pitchFamily="34" charset="0"/>
              </a:rPr>
              <a:t>cut</a:t>
            </a:r>
            <a:endParaRPr lang="en-US" sz="968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Rechteck 66"/>
          <p:cNvSpPr/>
          <p:nvPr/>
        </p:nvSpPr>
        <p:spPr>
          <a:xfrm>
            <a:off x="7926294" y="7206469"/>
            <a:ext cx="3001095" cy="55897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85"/>
          </a:p>
        </p:txBody>
      </p:sp>
      <p:sp>
        <p:nvSpPr>
          <p:cNvPr id="68" name="Textfeld 67"/>
          <p:cNvSpPr txBox="1"/>
          <p:nvPr/>
        </p:nvSpPr>
        <p:spPr>
          <a:xfrm>
            <a:off x="11030732" y="7343505"/>
            <a:ext cx="668773" cy="2548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6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SK-3</a:t>
            </a:r>
            <a:r>
              <a:rPr lang="el-GR" sz="1056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US" sz="1056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00066423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3</Words>
  <Application>Microsoft Office PowerPoint</Application>
  <PresentationFormat>Benutzerdefiniert</PresentationFormat>
  <Paragraphs>45</Paragraphs>
  <Slides>1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4" baseType="lpstr">
      <vt:lpstr>Arial</vt:lpstr>
      <vt:lpstr>Calibri</vt:lpstr>
      <vt:lpstr>Larissa</vt:lpstr>
      <vt:lpstr>PowerPoint-Präsentation</vt:lpstr>
    </vt:vector>
  </TitlesOfParts>
  <Company>Universitätsklinikum Ess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Lieder</dc:creator>
  <cp:lastModifiedBy>Helmut Lieder</cp:lastModifiedBy>
  <cp:revision>29</cp:revision>
  <dcterms:created xsi:type="dcterms:W3CDTF">2020-12-20T01:23:11Z</dcterms:created>
  <dcterms:modified xsi:type="dcterms:W3CDTF">2021-03-24T12:05:11Z</dcterms:modified>
</cp:coreProperties>
</file>